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60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110" d="100"/>
          <a:sy n="110" d="100"/>
        </p:scale>
        <p:origin x="756" y="-40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83181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38031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0943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0132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06136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83831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14402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33034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30977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29915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74285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52661E-D519-45A8-8177-5A46CF60E414}" type="datetimeFigureOut">
              <a:rPr lang="en-ZA" smtClean="0"/>
              <a:t>2023/08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75CEC-085B-4D6A-BE90-A9AD38706D5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00501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8A384A6-BEE1-57FC-1468-3D598EB1346B}"/>
              </a:ext>
            </a:extLst>
          </p:cNvPr>
          <p:cNvSpPr txBox="1"/>
          <p:nvPr/>
        </p:nvSpPr>
        <p:spPr>
          <a:xfrm>
            <a:off x="0" y="0"/>
            <a:ext cx="61899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Supplementary Table S1. Phenotype Collection Form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284144E-0C91-C1F8-30A7-B86837558B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3830924"/>
              </p:ext>
            </p:extLst>
          </p:nvPr>
        </p:nvGraphicFramePr>
        <p:xfrm>
          <a:off x="109056" y="189817"/>
          <a:ext cx="6610046" cy="946496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796452">
                  <a:extLst>
                    <a:ext uri="{9D8B030D-6E8A-4147-A177-3AD203B41FA5}">
                      <a16:colId xmlns:a16="http://schemas.microsoft.com/office/drawing/2014/main" val="1502585831"/>
                    </a:ext>
                  </a:extLst>
                </a:gridCol>
                <a:gridCol w="2394506">
                  <a:extLst>
                    <a:ext uri="{9D8B030D-6E8A-4147-A177-3AD203B41FA5}">
                      <a16:colId xmlns:a16="http://schemas.microsoft.com/office/drawing/2014/main" val="3939258681"/>
                    </a:ext>
                  </a:extLst>
                </a:gridCol>
                <a:gridCol w="854772">
                  <a:extLst>
                    <a:ext uri="{9D8B030D-6E8A-4147-A177-3AD203B41FA5}">
                      <a16:colId xmlns:a16="http://schemas.microsoft.com/office/drawing/2014/main" val="2317315389"/>
                    </a:ext>
                  </a:extLst>
                </a:gridCol>
                <a:gridCol w="854772">
                  <a:extLst>
                    <a:ext uri="{9D8B030D-6E8A-4147-A177-3AD203B41FA5}">
                      <a16:colId xmlns:a16="http://schemas.microsoft.com/office/drawing/2014/main" val="818235946"/>
                    </a:ext>
                  </a:extLst>
                </a:gridCol>
                <a:gridCol w="854772">
                  <a:extLst>
                    <a:ext uri="{9D8B030D-6E8A-4147-A177-3AD203B41FA5}">
                      <a16:colId xmlns:a16="http://schemas.microsoft.com/office/drawing/2014/main" val="4121793780"/>
                    </a:ext>
                  </a:extLst>
                </a:gridCol>
                <a:gridCol w="854772">
                  <a:extLst>
                    <a:ext uri="{9D8B030D-6E8A-4147-A177-3AD203B41FA5}">
                      <a16:colId xmlns:a16="http://schemas.microsoft.com/office/drawing/2014/main" val="1054933558"/>
                    </a:ext>
                  </a:extLst>
                </a:gridCol>
              </a:tblGrid>
              <a:tr h="62036">
                <a:tc gridSpan="6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Phenotype Form NICU Exomes Project Wits 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7001104"/>
                  </a:ext>
                </a:extLst>
              </a:tr>
              <a:tr h="109002">
                <a:tc gridSpan="6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Please complete the phenotype form below. 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9224666"/>
                  </a:ext>
                </a:extLst>
              </a:tr>
              <a:tr h="62036">
                <a:tc row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Recruitment Information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Patient Name and/or Study Number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4261563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Recruiting  Hospital 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1897730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Parent Name(s) and Contact No.(s)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9819226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Referring Doctor Name and Contact No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9400942"/>
                  </a:ext>
                </a:extLst>
              </a:tr>
              <a:tr h="62036">
                <a:tc rowSpan="10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Birth Parameter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Birth Weight (g)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40790297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irth weight centile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6707071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eight (cm)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096360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Height centile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5354702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ead Circumference (cm)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6328107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Head circumference centile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307070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PGAR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751048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PGAR centile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6391922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Sex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1696049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Specify other sex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5817539"/>
                  </a:ext>
                </a:extLst>
              </a:tr>
              <a:tr h="62036">
                <a:tc rowSpan="8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Neurological Assessment 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Has the infant experienced seizures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 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692938909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eizure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846388198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have neuropathy or nerve dysfunction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157663398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Neuropathy or nerve dysfunction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582262616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s the infant encephalopathic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886751878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ncephalopathy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724105176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oes the infant have any brain malformations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80106042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rain malformation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830602266"/>
                  </a:ext>
                </a:extLst>
              </a:tr>
              <a:tr h="118190">
                <a:tc rowSpan="17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Head and Facial Assessment 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5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oes the infant have any dysmorphic features affecting the following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86366172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Head and neck shape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89098576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Head and neck dysmorphism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68129527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ye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41810519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Eye dysmorphism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793306712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Ear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532096373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Ear dysmorphism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69275048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ose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839813353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Nose dysmorphism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914583277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Mouth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905516832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Mouth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519730723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Is the infant micro- or macrocephalic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144640323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Micro-/Macrocephaly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276564848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s the infant hearing impaired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61141162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Hearing impairment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83797180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Is the infant visually impaired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179692940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Visual impairment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491370868"/>
                  </a:ext>
                </a:extLst>
              </a:tr>
              <a:tr h="118190">
                <a:tc rowSpan="1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Cardiovascular and Respiratory Assessment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oes the infant have any cardiac defects or malformations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771294239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Cardiac malformation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702030271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Is the infant cardiomyopathic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27337167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rdiomyopathy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534967441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have any respiratory abnormalities or difficulties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079774109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espiratory difficulties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536724398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5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Metabolic Assessment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828555470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oes the infant have any inborn errors of metabolism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49160875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nborn errors of metabolism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2090874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display features of an autoimmune disorder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922361941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utoimmune disorder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431531785"/>
                  </a:ext>
                </a:extLst>
              </a:tr>
              <a:tr h="126410">
                <a:tc rowSpan="1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Abdominal and Genitourinary Assessment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5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oes the infant have any defects in the following organ systems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344252437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strointestinal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728311070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strointestinal defect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94766239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iver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49430415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iver defect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241712049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idney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4115549789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idney defect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429281382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enitourinary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506450196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enitourinary defect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83283511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have any other abnormalities along the trunk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203153416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unk abnormality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4242889886"/>
                  </a:ext>
                </a:extLst>
              </a:tr>
              <a:tr h="118190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ermatological Assessment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oes the infant have any dermatological features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453170680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ermatological features details 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831133488"/>
                  </a:ext>
                </a:extLst>
              </a:tr>
              <a:tr h="118190">
                <a:tc rowSpan="8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Skeletal and Muscle Assessment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oes the infant have any skeletal abnormalities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4265878720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keletal abnormality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973565312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have any joint abnormalities? 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609833301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Joint abnormality details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3427216745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have abnormal muscle tone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471231553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uscle tone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222348908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have any abnormalities of hands, feet or limbs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810992857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ands, feet and limb abnormality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440030453"/>
                  </a:ext>
                </a:extLst>
              </a:tr>
              <a:tr h="118190">
                <a:tc rowSpan="8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General and Behavioural Assessment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Is the infant failing to thrive?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02914977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iling to thrive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667731282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have an abnormal weight or growth parameters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691310973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Weight and growth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46398523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fatigue easily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4140677360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tigue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94560723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es the infant have feeding difficulties?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2805830554"/>
                  </a:ext>
                </a:extLst>
              </a:tr>
              <a:tr h="62036">
                <a:tc vMerge="1">
                  <a:txBody>
                    <a:bodyPr/>
                    <a:lstStyle/>
                    <a:p>
                      <a:endParaRPr lang="en-ZA" sz="800" kern="100" dirty="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eeding difficulties details</a:t>
                      </a: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extLst>
                  <a:ext uri="{0D108BD9-81ED-4DB2-BD59-A6C34878D82A}">
                    <a16:rowId xmlns:a16="http://schemas.microsoft.com/office/drawing/2014/main" val="111530262"/>
                  </a:ext>
                </a:extLst>
              </a:tr>
              <a:tr h="11819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Miscellaneous features and History: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Does the infant have any other relevant phenotypic features or history? Please provide details in the box below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6317709"/>
                  </a:ext>
                </a:extLst>
              </a:tr>
              <a:tr h="62036">
                <a:tc gridSpan="6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Thank you for completing</a:t>
                      </a:r>
                      <a:endParaRPr lang="en-ZA" sz="7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103" marR="23103" marT="0" marB="0"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81966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987940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3B2F6BA-AD5F-0746-C697-CAEBA07CFA0D}"/>
              </a:ext>
            </a:extLst>
          </p:cNvPr>
          <p:cNvSpPr txBox="1"/>
          <p:nvPr/>
        </p:nvSpPr>
        <p:spPr>
          <a:xfrm>
            <a:off x="129303" y="83938"/>
            <a:ext cx="6448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Supplementary Table S2. Neonatal-  and early-childhood-onset and founder and common African variant (NICU/African) gene panel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C329A371-23F2-EBA6-71EE-52B6953BF9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1181272"/>
              </p:ext>
            </p:extLst>
          </p:nvPr>
        </p:nvGraphicFramePr>
        <p:xfrm>
          <a:off x="204540" y="325403"/>
          <a:ext cx="6448919" cy="949665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495683">
                  <a:extLst>
                    <a:ext uri="{9D8B030D-6E8A-4147-A177-3AD203B41FA5}">
                      <a16:colId xmlns:a16="http://schemas.microsoft.com/office/drawing/2014/main" val="215137648"/>
                    </a:ext>
                  </a:extLst>
                </a:gridCol>
                <a:gridCol w="495683">
                  <a:extLst>
                    <a:ext uri="{9D8B030D-6E8A-4147-A177-3AD203B41FA5}">
                      <a16:colId xmlns:a16="http://schemas.microsoft.com/office/drawing/2014/main" val="4096394517"/>
                    </a:ext>
                  </a:extLst>
                </a:gridCol>
                <a:gridCol w="495683">
                  <a:extLst>
                    <a:ext uri="{9D8B030D-6E8A-4147-A177-3AD203B41FA5}">
                      <a16:colId xmlns:a16="http://schemas.microsoft.com/office/drawing/2014/main" val="2251984795"/>
                    </a:ext>
                  </a:extLst>
                </a:gridCol>
                <a:gridCol w="495683">
                  <a:extLst>
                    <a:ext uri="{9D8B030D-6E8A-4147-A177-3AD203B41FA5}">
                      <a16:colId xmlns:a16="http://schemas.microsoft.com/office/drawing/2014/main" val="1851081363"/>
                    </a:ext>
                  </a:extLst>
                </a:gridCol>
                <a:gridCol w="495683">
                  <a:extLst>
                    <a:ext uri="{9D8B030D-6E8A-4147-A177-3AD203B41FA5}">
                      <a16:colId xmlns:a16="http://schemas.microsoft.com/office/drawing/2014/main" val="2317559091"/>
                    </a:ext>
                  </a:extLst>
                </a:gridCol>
                <a:gridCol w="495683">
                  <a:extLst>
                    <a:ext uri="{9D8B030D-6E8A-4147-A177-3AD203B41FA5}">
                      <a16:colId xmlns:a16="http://schemas.microsoft.com/office/drawing/2014/main" val="1143115089"/>
                    </a:ext>
                  </a:extLst>
                </a:gridCol>
                <a:gridCol w="496403">
                  <a:extLst>
                    <a:ext uri="{9D8B030D-6E8A-4147-A177-3AD203B41FA5}">
                      <a16:colId xmlns:a16="http://schemas.microsoft.com/office/drawing/2014/main" val="3855181572"/>
                    </a:ext>
                  </a:extLst>
                </a:gridCol>
                <a:gridCol w="496403">
                  <a:extLst>
                    <a:ext uri="{9D8B030D-6E8A-4147-A177-3AD203B41FA5}">
                      <a16:colId xmlns:a16="http://schemas.microsoft.com/office/drawing/2014/main" val="3965765791"/>
                    </a:ext>
                  </a:extLst>
                </a:gridCol>
                <a:gridCol w="496403">
                  <a:extLst>
                    <a:ext uri="{9D8B030D-6E8A-4147-A177-3AD203B41FA5}">
                      <a16:colId xmlns:a16="http://schemas.microsoft.com/office/drawing/2014/main" val="117863816"/>
                    </a:ext>
                  </a:extLst>
                </a:gridCol>
                <a:gridCol w="496403">
                  <a:extLst>
                    <a:ext uri="{9D8B030D-6E8A-4147-A177-3AD203B41FA5}">
                      <a16:colId xmlns:a16="http://schemas.microsoft.com/office/drawing/2014/main" val="4034052264"/>
                    </a:ext>
                  </a:extLst>
                </a:gridCol>
                <a:gridCol w="496403">
                  <a:extLst>
                    <a:ext uri="{9D8B030D-6E8A-4147-A177-3AD203B41FA5}">
                      <a16:colId xmlns:a16="http://schemas.microsoft.com/office/drawing/2014/main" val="3736837049"/>
                    </a:ext>
                  </a:extLst>
                </a:gridCol>
                <a:gridCol w="496403">
                  <a:extLst>
                    <a:ext uri="{9D8B030D-6E8A-4147-A177-3AD203B41FA5}">
                      <a16:colId xmlns:a16="http://schemas.microsoft.com/office/drawing/2014/main" val="3162962171"/>
                    </a:ext>
                  </a:extLst>
                </a:gridCol>
                <a:gridCol w="496403">
                  <a:extLst>
                    <a:ext uri="{9D8B030D-6E8A-4147-A177-3AD203B41FA5}">
                      <a16:colId xmlns:a16="http://schemas.microsoft.com/office/drawing/2014/main" val="1576177901"/>
                    </a:ext>
                  </a:extLst>
                </a:gridCol>
              </a:tblGrid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AA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AR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A1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B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B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C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C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C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BCG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AD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80702187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AD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AD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AD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ADS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ADV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A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OX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SF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446688276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G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G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N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TN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VR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CVR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D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DAMTS1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DAMTSL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DCK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DCY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DGRV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73615786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D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G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G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GR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GX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HCY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HI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IFM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I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IR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K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KAP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KR1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082313346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A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DH18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DH3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DH5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DH7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DO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G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G1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G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G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G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M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187315944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OX12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OXE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P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LX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MEL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M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M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K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K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K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KR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KRD2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93749281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O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O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O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NTX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P3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P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PO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PO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PT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FGEF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G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HGEF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082992254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ID1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MC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S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S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R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SA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SC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S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SP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S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P1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P2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181452055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P6V0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P6V1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P7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P7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P8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TR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U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AVP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3GALT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AA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AG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B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BS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570951204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BS1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B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BS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BS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BS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BS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CH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CKDH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CKDH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CS1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DN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ICD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I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9316153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L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LOC1S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LOC1S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MPR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MP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RA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RC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RI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SCL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SN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T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BT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FAP29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494499430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CNA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CNA1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CNA1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CNA1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CNA1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CN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LM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LM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LR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PN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RD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S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71754220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SQ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S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TSPE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V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AV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B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B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2D2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DC10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DC11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DC15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DC3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DC4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788787918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DC5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DC6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CNO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24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3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3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3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3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40L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A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C7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H2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441308965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KL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KN1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KN2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DS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EACAM1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E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ENP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EP15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EP29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F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FL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F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FT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412919952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A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D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D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K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RN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RN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RN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HRN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I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ISD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CN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CNK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03258520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DN1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DN1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N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N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N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N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P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LR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NGB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C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11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11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17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22397487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1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1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2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3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4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4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4A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5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5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6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6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6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7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71235210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9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LQ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Q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ORO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P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PT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PT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REBB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RL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RTA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RYA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SF2R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38948242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SF2R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SRP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ST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T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TNN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TN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TS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TS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TS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UB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UL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YB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YB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65464755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YP11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YP11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YP21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YP27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YP27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YP4F2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CRY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2HGD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B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CLRE1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C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D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D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1853318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E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FNA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JV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GUO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HCR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IABLO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IAP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K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L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LL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M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M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MP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90343190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A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AF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AF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AF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H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H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H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I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I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JB1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JB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A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78670738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NMT3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CK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OK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PAG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R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S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SG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S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SP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UOX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UOX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DYX1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D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671925515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DA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DARAD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DN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DNR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FEMP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FH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FTUD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G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IF2AK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LAN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L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M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N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289462512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NP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PM2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RC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RCC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RCC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RCC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RCC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SCO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SP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SRR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TF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TF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TFD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06120809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THE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V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V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X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XT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Y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Y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EZH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1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13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13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798042077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M126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M16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M20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M58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45025282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D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I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ANC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BLN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B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BN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B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G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G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52075704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G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GD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GF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GFR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GFR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G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H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KBP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KT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LC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LN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OLR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734194927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OX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OX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OXE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OX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OXP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RA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T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UC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FX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6P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6PC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6P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4149275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L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L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LK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LN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L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M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S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T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T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T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T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TA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803733588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AT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B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BE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CD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C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C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DA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DF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DN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FA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FM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FP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GC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585581481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I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IPC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J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JA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J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J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JB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J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L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L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LD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LI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061180565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LR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LU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M2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N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NM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NPTA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NPT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N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1B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1B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C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90843381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D1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R14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R5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R9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PSM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RHL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RHP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RXCR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S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US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Y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GY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1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416571817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AD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ADH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ADH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AM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AR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AR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B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B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B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BG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CN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DAC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EX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78271032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EX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FE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G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G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GSNA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IN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LC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MGC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MGC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NF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NF1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NF4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P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125240033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PR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P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PS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PS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PS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PS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RA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SD11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SD17B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SD17B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SD17B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SD3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SD3B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513488754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SPB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SPG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TR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T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YA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HYDI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D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DU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GHMBP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GS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KBKA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KBK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L10R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691022205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L21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L2R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L2R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L7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LDR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N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NS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NV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QC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RF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SP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TG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TGA2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003982077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TGB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TGB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T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V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IY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JAG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JAK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JPH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JPH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JU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ANS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AR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AT6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857303572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BTBD1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A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D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E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E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E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H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J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J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J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J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J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76103597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K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Q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NQ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CTD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DM6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IF2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I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LHL4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LHL4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MT2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RA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RT1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RT1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83960050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RT1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RT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KRT6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1CA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M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M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M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M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MB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M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MP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RG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AR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21865528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B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C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DB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DL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DLRA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EP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HFPL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HX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IF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IG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IP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ITA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MBR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950606534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MN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MOD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MX1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OXH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RP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RP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RPPR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RRC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RSAM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RTOM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TBP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LYS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F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622342648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GI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G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N2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NB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P2K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P2K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RVELD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T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A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BTP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CC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CC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CFD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94223548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CIDA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COL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CP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ECP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ED1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EFV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EGF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E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FN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FSD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G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IR9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IT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325991753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KK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K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L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L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LYC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MA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MA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MACH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MADH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OC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OC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PI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P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58675858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PV1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PZ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SH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SH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SRB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SX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THF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TM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T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TR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TT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US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U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61176547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UTY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V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BPC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C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H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H1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H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H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H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H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H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L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L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49166708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L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LK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O15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O3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O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O7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OZ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MYP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AA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ADK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AG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AGLU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AG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078038617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AR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BEAL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B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C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CF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D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E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EF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EU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EURO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EX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F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84956215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FK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GLY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HEJ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HLR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IPAL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IPB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KX2-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KX2-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KX2-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LRP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ME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ODA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O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54100804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OTCH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OTCH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P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P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PH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PHP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PHP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PH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R0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S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SDH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NTRK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A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48696884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BS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C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CR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F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P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P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PLA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R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SBPL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SM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STM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T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TO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20455447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TO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TO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OTOG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2RX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2RY1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A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AK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AL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ANK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AX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AX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AX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04081840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CB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CC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CC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CDH1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CN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CSK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DE4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DH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DH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DX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DZD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055114301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1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1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2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EX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FK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GAM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HF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HK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HK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HKG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574175132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HOX2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HY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IEZO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IK3C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INK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K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KD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KH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KL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KP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LA2G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LAU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LCE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20353180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LCG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L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L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LO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MM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MP2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MS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NK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NK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N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NPO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L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L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05889594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LR1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LR1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MT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RC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U1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U3F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OU4F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P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QB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DM1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KAC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51364851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KAG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KAR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KD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O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OK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O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O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P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R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SA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SE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SEN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TC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998557552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TE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TH1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TPN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TPR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TPRQ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TR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T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YG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PYGM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QDP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B2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B27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B3GA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990607787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B7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D5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D51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G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G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PS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S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ASGRP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B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BM2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BM8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D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227521428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E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E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I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MR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NASEH2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NASEH2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NASEH2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G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L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L1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L2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L2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L3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805767582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L35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L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1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1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1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2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2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2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2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2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6K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PS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325802341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RM2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SPH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SPH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SPH4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SPH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UNX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UNX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YR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RY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1P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AC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AL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880702814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AMH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BD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1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1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3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4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4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5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N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N1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NN1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CO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38884391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DH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DHAF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DH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DH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DH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EPT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ERPIN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ETB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ET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FTP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FTP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GC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GC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632240945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GC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GC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GS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H2D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H3T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HANK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H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I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IX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IX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KI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12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12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61691246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12A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16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17A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17A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19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19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2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2A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5A1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5A1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5A2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5A3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5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10499749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6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6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6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7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A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2A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34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34A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35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37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39A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3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95942926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45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46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4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4A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5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5A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6A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6A8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7A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7A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9A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CO2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ITRK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484753156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LX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MAD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MAD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MAD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MARCAL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MC1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MN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MP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MP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NAI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NT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OX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OX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2960253284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P1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PAG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PINK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P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PRED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PT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PT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PTL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RCA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RY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AC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A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AT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48068353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K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RA6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R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X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XB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TXBP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UCLA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UCLG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UM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UOX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UR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SYNE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540886253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A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AZ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BC1D2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BX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BX1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BX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CA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CIRG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CN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COF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ECT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ER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ER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396903716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FAP2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FAP2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F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F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GF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GFB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GFBR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GFB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GM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GM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H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HR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583594565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HR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IMM8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INF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K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M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MEM12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MEM4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MIE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MPO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MPRSS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NFRSF11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NFSF1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NN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986756549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NNI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NNI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NN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NNT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NNT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P5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PM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PO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P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PR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APP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D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EX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1552482945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H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IM3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IM3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IOB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MU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RPM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SC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S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SEN5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SH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SH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SPEA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SR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774462721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TC25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TC37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TC7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T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TP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T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WIS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WNK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YM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Y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TYRP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BE2T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BR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791009220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GT1A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MO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NC13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ROD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RO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SH1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SH1G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USH2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CA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C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CP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D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HL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3437986597"/>
                  </a:ext>
                </a:extLst>
              </a:tr>
              <a:tr h="653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IPAS3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LDLR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PS13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PS13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PS33B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VWF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WAS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WDR6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WFS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WHR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WNT10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WRN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WT1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38521155"/>
                  </a:ext>
                </a:extLst>
              </a:tr>
              <a:tr h="987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XPA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XPC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ZAP7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ZEB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ZIC2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ZIC3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ZMPSTE24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ZMYND10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ZNF469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 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 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>
                          <a:effectLst/>
                        </a:rPr>
                        <a:t> </a:t>
                      </a:r>
                      <a:endParaRPr lang="en-ZA" sz="7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700" kern="100" dirty="0">
                          <a:effectLst/>
                        </a:rPr>
                        <a:t> </a:t>
                      </a:r>
                      <a:endParaRPr lang="en-ZA" sz="7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2770" marR="12770" marT="0" marB="0"/>
                </a:tc>
                <a:extLst>
                  <a:ext uri="{0D108BD9-81ED-4DB2-BD59-A6C34878D82A}">
                    <a16:rowId xmlns:a16="http://schemas.microsoft.com/office/drawing/2014/main" val="42463206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82963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02</TotalTime>
  <Words>1667</Words>
  <Application>Microsoft Office PowerPoint</Application>
  <PresentationFormat>A4 Paper (210x297 mm)</PresentationFormat>
  <Paragraphs>128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Campbell</dc:creator>
  <cp:lastModifiedBy>Lisa Campbell</cp:lastModifiedBy>
  <cp:revision>2</cp:revision>
  <dcterms:created xsi:type="dcterms:W3CDTF">2023-08-02T20:56:03Z</dcterms:created>
  <dcterms:modified xsi:type="dcterms:W3CDTF">2023-08-15T08:51:15Z</dcterms:modified>
</cp:coreProperties>
</file>